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6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5" d="100"/>
          <a:sy n="125" d="100"/>
        </p:scale>
        <p:origin x="3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jehr\Google%20Drive\OptiStrat\Metabolic-Profiling\Versuch46_Metabolic_GC-MS_Wdh1\2017-10_weigh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50.Versuch_HD_HD-sucrose_HD-EAA\Assays\Glucose+Glycogen\2018-04-27_Protein-Glucose-Glycogen_Auswertung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50.Versuch_HD_HD-sucrose_HD-EAA\Assays\Glucose+Glycogen\2018-04-27_Protein-Glucose-Glycogen_Auswertung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50.Versuch_HD_HD-sucrose_HD-EAA\Assays\Lactate\2018-04-27_Lactate-Proteine_Auswertung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46.Versuch_Metabolic_GC-MS_Wdh1\metabolic_assays\Glucose+Glycogen_Protein\2017-10-20_Protein-Glucose-Glycogen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46.Versuch_Metabolic_GC-MS_Wdh1\metabolic_assays\Glucose+Glycogen_Protein\2017-10-20_Protein-Glucose-Glycogen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46.Versuch_Metabolic_GC-MS_Wdh1\metabolic_assays\Lactate_Protein\2017-10-20_Lactate_BCA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50.Versuch_HD_HD-sucrose_HD-EAA\2018-04_V50_weights_larvae_H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50.Versuch_HD_HD-sucrose_HD-EAA\2018-04_V50_weights_larvae_H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46.Versuch_Metabolic_GC-MS_Wdh1\metabolic_assays\TAG_Protein\2017-10-20_TAG-BC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46.Versuch_Metabolic_GC-MS_Wdh1\metabolic_assays\Glycerol_Protein\2017-10-20_Glycerol-BC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46.Versuch_Metabolic_GC-MS_Wdh1\metabolic_assays\Glycerol_Protein\2017-10-20_Glycerol-BC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50.Versuch_HD_HD-sucrose_HD-EAA\Assays\TAG+Proteine\2018-04-27_TAG-Proteine_Auswertung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50.Versuch_HD_HD-sucrose_HD-EAA\Assays\TAG+Proteine\2018-04-27_TAG-Proteine_Auswertung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sa\Dokumente\Ergebnisse_Labor\Metabolitmessungen\50.Versuch_HD_HD-sucrose_HD-EAA\Assays\Glycerol\2017-10-20_Glycerol-BCA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HD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'wet weight'!$B$2,'wet weight'!$B$26,'wet weight'!$B$50)</c:f>
              <c:strCache>
                <c:ptCount val="3"/>
                <c:pt idx="0">
                  <c:v>96 h</c:v>
                </c:pt>
                <c:pt idx="1">
                  <c:v>132 h</c:v>
                </c:pt>
                <c:pt idx="2">
                  <c:v>168 h</c:v>
                </c:pt>
              </c:strCache>
            </c:strRef>
          </c:cat>
          <c:val>
            <c:numRef>
              <c:f>('wet weight'!$G$2,'wet weight'!$G$26,'wet weight'!$G$50)</c:f>
              <c:numCache>
                <c:formatCode>0,000</c:formatCode>
                <c:ptCount val="3"/>
                <c:pt idx="0">
                  <c:v>0.33812500000000018</c:v>
                </c:pt>
                <c:pt idx="1">
                  <c:v>0.79868055555555639</c:v>
                </c:pt>
                <c:pt idx="2">
                  <c:v>1.801041666666671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8A5-455A-8E06-1DAAA4E5BE66}"/>
            </c:ext>
          </c:extLst>
        </c:ser>
        <c:ser>
          <c:idx val="1"/>
          <c:order val="1"/>
          <c:tx>
            <c:v>HD + 2x sucrose</c:v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wet weight'!$B$2,'wet weight'!$B$26,'wet weight'!$B$50)</c:f>
              <c:strCache>
                <c:ptCount val="3"/>
                <c:pt idx="0">
                  <c:v>96 h</c:v>
                </c:pt>
                <c:pt idx="1">
                  <c:v>132 h</c:v>
                </c:pt>
                <c:pt idx="2">
                  <c:v>168 h</c:v>
                </c:pt>
              </c:strCache>
            </c:strRef>
          </c:cat>
          <c:val>
            <c:numRef>
              <c:f>('wet weight'!$G$14,'wet weight'!$G$38,'wet weight'!$G$62)</c:f>
              <c:numCache>
                <c:formatCode>0,000</c:formatCode>
                <c:ptCount val="3"/>
                <c:pt idx="0">
                  <c:v>0.29131249999999798</c:v>
                </c:pt>
                <c:pt idx="1">
                  <c:v>0.92270833333333324</c:v>
                </c:pt>
                <c:pt idx="2">
                  <c:v>1.537916666666667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8A5-455A-8E06-1DAAA4E5BE66}"/>
            </c:ext>
          </c:extLst>
        </c:ser>
        <c:ser>
          <c:idx val="2"/>
          <c:order val="2"/>
          <c:tx>
            <c:v>HD + 2x EAA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'wet weight'!$B$2,'wet weight'!$B$26,'wet weight'!$B$50)</c:f>
              <c:strCache>
                <c:ptCount val="3"/>
                <c:pt idx="0">
                  <c:v>96 h</c:v>
                </c:pt>
                <c:pt idx="1">
                  <c:v>132 h</c:v>
                </c:pt>
                <c:pt idx="2">
                  <c:v>168 h</c:v>
                </c:pt>
              </c:strCache>
            </c:strRef>
          </c:cat>
          <c:val>
            <c:numRef>
              <c:f>('wet weight'!$G$22,'wet weight'!$G$46,'wet weight'!$G$70)</c:f>
              <c:numCache>
                <c:formatCode>0,000</c:formatCode>
                <c:ptCount val="3"/>
                <c:pt idx="0" formatCode="General">
                  <c:v>0.48799999999999955</c:v>
                </c:pt>
                <c:pt idx="1">
                  <c:v>1.584374999999999</c:v>
                </c:pt>
                <c:pt idx="2">
                  <c:v>1.800000000000002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08A5-455A-8E06-1DAAA4E5B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3299320"/>
        <c:axId val="143299712"/>
      </c:lineChart>
      <c:catAx>
        <c:axId val="143299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3299712"/>
        <c:crosses val="autoZero"/>
        <c:auto val="1"/>
        <c:lblAlgn val="ctr"/>
        <c:lblOffset val="100"/>
        <c:noMultiLvlLbl val="0"/>
      </c:catAx>
      <c:valAx>
        <c:axId val="1432997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g wet</a:t>
                </a:r>
                <a:r>
                  <a:rPr lang="en-US" sz="1050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weight / animal</a:t>
                </a:r>
                <a:endParaRPr lang="en-US" sz="105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32993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9819753086419758"/>
          <c:y val="0.61262888888888889"/>
          <c:w val="0.388439172536581"/>
          <c:h val="0.19819388888888889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28575"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2018-04-27_Protein-Glucose-Glycogen_Auswertung.xlsx]Auswertung'!$P$62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  <a:effectLst/>
            </c:spPr>
          </c:marker>
          <c:cat>
            <c:strRef>
              <c:f>'[2018-04-27_Protein-Glucose-Glycogen_Auswertung.xlsx]Auswertung'!$O$86,'[2018-04-27_Protein-Glucose-Glycogen_Auswertung.xlsx]Auswertung'!$O$90,'[2018-04-27_Protein-Glucose-Glycogen_Auswertung.xlsx]Auswertung'!$O$94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'[2018-04-27_Protein-Glucose-Glycogen_Auswertung.xlsx]Auswertung'!$M$62,'[2018-04-27_Protein-Glucose-Glycogen_Auswertung.xlsx]Auswertung'!$M$67,'[2018-04-27_Protein-Glucose-Glycogen_Auswertung.xlsx]Auswertung'!$M$70</c:f>
              <c:numCache>
                <c:formatCode>General</c:formatCode>
                <c:ptCount val="3"/>
                <c:pt idx="0">
                  <c:v>0.17726083333333334</c:v>
                </c:pt>
                <c:pt idx="2">
                  <c:v>1.285622395833333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2018-04-27_Protein-Glucose-Glycogen_Auswertung.xlsx]Auswertung'!$P$74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25400">
                <a:solidFill>
                  <a:schemeClr val="accent1"/>
                </a:solidFill>
              </a:ln>
              <a:effectLst/>
            </c:spPr>
          </c:marker>
          <c:cat>
            <c:strRef>
              <c:f>'[2018-04-27_Protein-Glucose-Glycogen_Auswertung.xlsx]Auswertung'!$O$86,'[2018-04-27_Protein-Glucose-Glycogen_Auswertung.xlsx]Auswertung'!$O$90,'[2018-04-27_Protein-Glucose-Glycogen_Auswertung.xlsx]Auswertung'!$O$94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'[2018-04-27_Protein-Glucose-Glycogen_Auswertung.xlsx]Auswertung'!$M$75,'[2018-04-27_Protein-Glucose-Glycogen_Auswertung.xlsx]Auswertung'!$M$79,'[2018-04-27_Protein-Glucose-Glycogen_Auswertung.xlsx]Auswertung'!$M$82</c:f>
              <c:numCache>
                <c:formatCode>General</c:formatCode>
                <c:ptCount val="3"/>
                <c:pt idx="2">
                  <c:v>0.7698463541666666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[2018-04-27_Protein-Glucose-Glycogen_Auswertung.xlsx]Auswertung'!$P$86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'[2018-04-27_Protein-Glucose-Glycogen_Auswertung.xlsx]Auswertung'!$O$86,'[2018-04-27_Protein-Glucose-Glycogen_Auswertung.xlsx]Auswertung'!$O$90,'[2018-04-27_Protein-Glucose-Glycogen_Auswertung.xlsx]Auswertung'!$O$94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'[2018-04-27_Protein-Glucose-Glycogen_Auswertung.xlsx]Auswertung'!$M$86,'[2018-04-27_Protein-Glucose-Glycogen_Auswertung.xlsx]Auswertung'!$M$90,'[2018-04-27_Protein-Glucose-Glycogen_Auswertung.xlsx]Auswertung'!$M$94</c:f>
              <c:numCache>
                <c:formatCode>General</c:formatCode>
                <c:ptCount val="3"/>
                <c:pt idx="0">
                  <c:v>0.20604833333333333</c:v>
                </c:pt>
                <c:pt idx="1">
                  <c:v>0.61391406250000014</c:v>
                </c:pt>
                <c:pt idx="2">
                  <c:v>2.77297656250000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561904"/>
        <c:axId val="194676160"/>
      </c:lineChart>
      <c:catAx>
        <c:axId val="193561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4676160"/>
        <c:crosses val="autoZero"/>
        <c:auto val="1"/>
        <c:lblAlgn val="ctr"/>
        <c:lblOffset val="100"/>
        <c:noMultiLvlLbl val="0"/>
      </c:catAx>
      <c:valAx>
        <c:axId val="194676160"/>
        <c:scaling>
          <c:orientation val="minMax"/>
          <c:max val="6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µg glucose / </a:t>
                </a:r>
                <a:r>
                  <a:rPr lang="en-US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imal</a:t>
                </a:r>
                <a:endParaRPr lang="en-US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561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474475308641975"/>
          <c:y val="6.8543333333333345E-2"/>
          <c:w val="0.36062561728395071"/>
          <c:h val="0.2282099999999999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2018-04-27_Protein-Glucose-Glycogen_Auswertung.xlsx]Auswertung'!$Q$114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[2018-04-27_Protein-Glucose-Glycogen_Auswertung.xlsx]Auswertung'!$P$138,'[2018-04-27_Protein-Glucose-Glycogen_Auswertung.xlsx]Auswertung'!$P$142,'[2018-04-27_Protein-Glucose-Glycogen_Auswertung.xlsx]Auswertung'!$P$146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'[2018-04-27_Protein-Glucose-Glycogen_Auswertung.xlsx]Auswertung'!$N$114,'[2018-04-27_Protein-Glucose-Glycogen_Auswertung.xlsx]Auswertung'!$N$118,'[2018-04-27_Protein-Glucose-Glycogen_Auswertung.xlsx]Auswertung'!$N$122</c:f>
              <c:numCache>
                <c:formatCode>General</c:formatCode>
                <c:ptCount val="3"/>
                <c:pt idx="0">
                  <c:v>1.1928017000000002</c:v>
                </c:pt>
                <c:pt idx="1">
                  <c:v>3.1100726041666671</c:v>
                </c:pt>
                <c:pt idx="2">
                  <c:v>11.19543270833333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2018-04-27_Protein-Glucose-Glycogen_Auswertung.xlsx]Auswertung'!$Q$126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[2018-04-27_Protein-Glucose-Glycogen_Auswertung.xlsx]Auswertung'!$P$138,'[2018-04-27_Protein-Glucose-Glycogen_Auswertung.xlsx]Auswertung'!$P$142,'[2018-04-27_Protein-Glucose-Glycogen_Auswertung.xlsx]Auswertung'!$P$146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'[2018-04-27_Protein-Glucose-Glycogen_Auswertung.xlsx]Auswertung'!$N$126,'[2018-04-27_Protein-Glucose-Glycogen_Auswertung.xlsx]Auswertung'!$N$130,'[2018-04-27_Protein-Glucose-Glycogen_Auswertung.xlsx]Auswertung'!$N$134</c:f>
              <c:numCache>
                <c:formatCode>General</c:formatCode>
                <c:ptCount val="3"/>
                <c:pt idx="0">
                  <c:v>2.3386070333333335</c:v>
                </c:pt>
                <c:pt idx="1">
                  <c:v>4.4150919791666672</c:v>
                </c:pt>
                <c:pt idx="2">
                  <c:v>12.21434875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[2018-04-27_Protein-Glucose-Glycogen_Auswertung.xlsx]Auswertung'!$Q$138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'[2018-04-27_Protein-Glucose-Glycogen_Auswertung.xlsx]Auswertung'!$P$138,'[2018-04-27_Protein-Glucose-Glycogen_Auswertung.xlsx]Auswertung'!$P$142,'[2018-04-27_Protein-Glucose-Glycogen_Auswertung.xlsx]Auswertung'!$P$146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'[2018-04-27_Protein-Glucose-Glycogen_Auswertung.xlsx]Auswertung'!$N$138,'[2018-04-27_Protein-Glucose-Glycogen_Auswertung.xlsx]Auswertung'!$N$142,'[2018-04-27_Protein-Glucose-Glycogen_Auswertung.xlsx]Auswertung'!$N$146</c:f>
              <c:numCache>
                <c:formatCode>General</c:formatCode>
                <c:ptCount val="3"/>
                <c:pt idx="0">
                  <c:v>1.9740696</c:v>
                </c:pt>
                <c:pt idx="1">
                  <c:v>4.9175197916666669</c:v>
                </c:pt>
                <c:pt idx="2">
                  <c:v>10.50995791666666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4676944"/>
        <c:axId val="194677336"/>
      </c:lineChart>
      <c:catAx>
        <c:axId val="194676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4677336"/>
        <c:crosses val="autoZero"/>
        <c:auto val="1"/>
        <c:lblAlgn val="ctr"/>
        <c:lblOffset val="100"/>
        <c:noMultiLvlLbl val="0"/>
      </c:catAx>
      <c:valAx>
        <c:axId val="1946773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µg glycogen / anima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46769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8320154320987656"/>
          <c:y val="0.10817277777777778"/>
          <c:w val="0.37189104938271605"/>
          <c:h val="0.2326172222222222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uswertung!$Q$66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P$66,Auswertung!$P$70,Auswertung!$P$74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N$66,Auswertung!$N$70,Auswertung!$N$74)</c:f>
              <c:numCache>
                <c:formatCode>General</c:formatCode>
                <c:ptCount val="3"/>
                <c:pt idx="0">
                  <c:v>1.59022</c:v>
                </c:pt>
                <c:pt idx="1">
                  <c:v>3.2622499999999999</c:v>
                </c:pt>
                <c:pt idx="2">
                  <c:v>3.622437500000000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Q$78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P$66,Auswertung!$P$70,Auswertung!$P$74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N$78,Auswertung!$N$82,Auswertung!$N$86)</c:f>
              <c:numCache>
                <c:formatCode>General</c:formatCode>
                <c:ptCount val="3"/>
                <c:pt idx="0">
                  <c:v>1.4438800000000001</c:v>
                </c:pt>
                <c:pt idx="1">
                  <c:v>4.9624999999999995</c:v>
                </c:pt>
                <c:pt idx="2">
                  <c:v>3.5416249999999998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Q$90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P$66,Auswertung!$P$70,Auswertung!$P$74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N$90,Auswertung!$N$94,Auswertung!$N$98)</c:f>
              <c:numCache>
                <c:formatCode>General</c:formatCode>
                <c:ptCount val="3"/>
                <c:pt idx="0">
                  <c:v>1.7499399999999998</c:v>
                </c:pt>
                <c:pt idx="1">
                  <c:v>3.6612499999999999</c:v>
                </c:pt>
                <c:pt idx="2">
                  <c:v>6.7375625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4678120"/>
        <c:axId val="194678512"/>
      </c:lineChart>
      <c:catAx>
        <c:axId val="1946781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4678512"/>
        <c:crosses val="autoZero"/>
        <c:auto val="1"/>
        <c:lblAlgn val="ctr"/>
        <c:lblOffset val="100"/>
        <c:noMultiLvlLbl val="0"/>
      </c:catAx>
      <c:valAx>
        <c:axId val="194678512"/>
        <c:scaling>
          <c:orientation val="minMax"/>
          <c:max val="18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mol</a:t>
                </a:r>
                <a:r>
                  <a:rPr lang="en-US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actate / animal</a:t>
                </a:r>
                <a:endParaRPr lang="en-US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4678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7573086419753087"/>
          <c:y val="7.8477222222222212E-2"/>
          <c:w val="0.39689598765432099"/>
          <c:h val="0.24030388888888884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uswertung!$Q$62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P$86,Auswertung!$P$90,Auswertung!$P$94)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(Auswertung!$N$62,Auswertung!$N$66,Auswertung!$N$70)</c:f>
              <c:numCache>
                <c:formatCode>General</c:formatCode>
                <c:ptCount val="3"/>
                <c:pt idx="0">
                  <c:v>0.13827719999999999</c:v>
                </c:pt>
                <c:pt idx="1">
                  <c:v>0.44785833333333325</c:v>
                </c:pt>
                <c:pt idx="2">
                  <c:v>2.092906041666666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Q$74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P$86,Auswertung!$P$90,Auswertung!$P$94)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(Auswertung!$N$74,Auswertung!$N$78,Auswertung!$N$82)</c:f>
              <c:numCache>
                <c:formatCode>General</c:formatCode>
                <c:ptCount val="3"/>
                <c:pt idx="0">
                  <c:v>0.14667297777777777</c:v>
                </c:pt>
                <c:pt idx="1">
                  <c:v>0.29043749999999974</c:v>
                </c:pt>
                <c:pt idx="2">
                  <c:v>1.597030416666666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Q$86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P$86,Auswertung!$P$90,Auswertung!$P$94)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(Auswertung!$N$86,Auswertung!$N$90,Auswertung!$N$94)</c:f>
              <c:numCache>
                <c:formatCode>General</c:formatCode>
                <c:ptCount val="3"/>
                <c:pt idx="0">
                  <c:v>0.97953413333333339</c:v>
                </c:pt>
                <c:pt idx="1">
                  <c:v>2.5966527083333335</c:v>
                </c:pt>
                <c:pt idx="2">
                  <c:v>5.154741249999998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6505632"/>
        <c:axId val="296502888"/>
      </c:lineChart>
      <c:catAx>
        <c:axId val="296505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6502888"/>
        <c:crosses val="autoZero"/>
        <c:auto val="1"/>
        <c:lblAlgn val="ctr"/>
        <c:lblOffset val="100"/>
        <c:noMultiLvlLbl val="0"/>
      </c:catAx>
      <c:valAx>
        <c:axId val="2965028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µg glucose / </a:t>
                </a:r>
                <a:r>
                  <a:rPr lang="en-US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imal</a:t>
                </a:r>
                <a:endParaRPr lang="en-US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65056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779854938271605"/>
          <c:y val="4.9821111111111108E-2"/>
          <c:w val="0.36454537037037038"/>
          <c:h val="0.17882108486439194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uswertung!$R$114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Q$138,Auswertung!$Q$142,Auswertung!$Q$146)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(Auswertung!$O$114,Auswertung!$O$118,Auswertung!$O$122)</c:f>
              <c:numCache>
                <c:formatCode>General</c:formatCode>
                <c:ptCount val="3"/>
                <c:pt idx="0">
                  <c:v>1.5207058666666666</c:v>
                </c:pt>
                <c:pt idx="1">
                  <c:v>3.4145752083333338</c:v>
                </c:pt>
                <c:pt idx="2">
                  <c:v>7.882068541666667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R$126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Q$138,Auswertung!$Q$142,Auswertung!$Q$146)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(Auswertung!$O$126,Auswertung!$O$130,Auswertung!$O$134)</c:f>
              <c:numCache>
                <c:formatCode>General</c:formatCode>
                <c:ptCount val="3"/>
                <c:pt idx="0">
                  <c:v>2.2786732000000005</c:v>
                </c:pt>
                <c:pt idx="1">
                  <c:v>5.1455450000000011</c:v>
                </c:pt>
                <c:pt idx="2">
                  <c:v>8.5674050000000008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R$138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Q$138,Auswertung!$Q$142,Auswertung!$Q$146)</c:f>
              <c:strCache>
                <c:ptCount val="3"/>
                <c:pt idx="0">
                  <c:v>96h</c:v>
                </c:pt>
                <c:pt idx="1">
                  <c:v>132h </c:v>
                </c:pt>
                <c:pt idx="2">
                  <c:v>168h </c:v>
                </c:pt>
              </c:strCache>
            </c:strRef>
          </c:cat>
          <c:val>
            <c:numRef>
              <c:f>(Auswertung!$O$138,Auswertung!$O$142,Auswertung!$O$146)</c:f>
              <c:numCache>
                <c:formatCode>General</c:formatCode>
                <c:ptCount val="3"/>
                <c:pt idx="0">
                  <c:v>1.3788300666666669</c:v>
                </c:pt>
                <c:pt idx="1">
                  <c:v>5.8897010416666671</c:v>
                </c:pt>
                <c:pt idx="2">
                  <c:v>10.90327937500000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12440040"/>
        <c:axId val="312438080"/>
      </c:lineChart>
      <c:catAx>
        <c:axId val="312440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2438080"/>
        <c:crosses val="autoZero"/>
        <c:auto val="1"/>
        <c:lblAlgn val="ctr"/>
        <c:lblOffset val="100"/>
        <c:noMultiLvlLbl val="0"/>
      </c:catAx>
      <c:valAx>
        <c:axId val="312438080"/>
        <c:scaling>
          <c:orientation val="minMax"/>
          <c:max val="14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µg glycogen / anima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24400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280030864197532"/>
          <c:y val="8.7006111111111117E-2"/>
          <c:w val="0.35621203703703702"/>
          <c:h val="0.19733960338291046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uswertung!$R$66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Q$66,Auswertung!$Q$70,Auswertung!$Q$74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O$66,Auswertung!$O$70,Auswertung!$O$74)</c:f>
              <c:numCache>
                <c:formatCode>General</c:formatCode>
                <c:ptCount val="3"/>
                <c:pt idx="0">
                  <c:v>3.4142999999999999</c:v>
                </c:pt>
                <c:pt idx="1">
                  <c:v>9.5002499999999976</c:v>
                </c:pt>
                <c:pt idx="2">
                  <c:v>9.746562499999999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R$78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Q$66,Auswertung!$Q$70,Auswertung!$Q$74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O$78,Auswertung!$O$82,Auswertung!$O$86)</c:f>
              <c:numCache>
                <c:formatCode>General</c:formatCode>
                <c:ptCount val="3"/>
                <c:pt idx="0">
                  <c:v>3.7584199999999996</c:v>
                </c:pt>
                <c:pt idx="1">
                  <c:v>9.5838125000000005</c:v>
                </c:pt>
                <c:pt idx="2">
                  <c:v>11.05162500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R$90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Q$66,Auswertung!$Q$70,Auswertung!$Q$74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O$90,Auswertung!$O$94,Auswertung!$O$98)</c:f>
              <c:numCache>
                <c:formatCode>General</c:formatCode>
                <c:ptCount val="3"/>
                <c:pt idx="0">
                  <c:v>6.1909200000000002</c:v>
                </c:pt>
                <c:pt idx="1">
                  <c:v>14.839062500000001</c:v>
                </c:pt>
                <c:pt idx="2">
                  <c:v>15.4165625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3461232"/>
        <c:axId val="303924296"/>
      </c:lineChart>
      <c:catAx>
        <c:axId val="293461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3924296"/>
        <c:crosses val="autoZero"/>
        <c:auto val="1"/>
        <c:lblAlgn val="ctr"/>
        <c:lblOffset val="100"/>
        <c:noMultiLvlLbl val="0"/>
      </c:catAx>
      <c:valAx>
        <c:axId val="3039242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mol</a:t>
                </a:r>
                <a:r>
                  <a:rPr lang="en-US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actate / animal</a:t>
                </a:r>
                <a:endParaRPr lang="en-US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34612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9387407407407411"/>
          <c:y val="0.61905166666666667"/>
          <c:w val="0.36553796296296298"/>
          <c:h val="0.1768040974044911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HD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results!$B$5,results!$B$10,results!$B$13)</c:f>
              <c:strCache>
                <c:ptCount val="3"/>
                <c:pt idx="0">
                  <c:v>96 h</c:v>
                </c:pt>
                <c:pt idx="1">
                  <c:v>132 h</c:v>
                </c:pt>
                <c:pt idx="2">
                  <c:v>168 h</c:v>
                </c:pt>
              </c:strCache>
            </c:strRef>
          </c:cat>
          <c:val>
            <c:numRef>
              <c:f>(results!$E$4,results!$E$8,results!$E$12)</c:f>
              <c:numCache>
                <c:formatCode>0.000</c:formatCode>
                <c:ptCount val="3"/>
                <c:pt idx="0">
                  <c:v>0.25675000000000059</c:v>
                </c:pt>
                <c:pt idx="1">
                  <c:v>0.68249999999999977</c:v>
                </c:pt>
                <c:pt idx="2">
                  <c:v>1.659375000000002</c:v>
                </c:pt>
              </c:numCache>
            </c:numRef>
          </c:val>
          <c:smooth val="0"/>
        </c:ser>
        <c:ser>
          <c:idx val="1"/>
          <c:order val="1"/>
          <c:tx>
            <c:v>HD + 2x sucrose</c:v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results!$B$5,results!$B$10,results!$B$13)</c:f>
              <c:strCache>
                <c:ptCount val="3"/>
                <c:pt idx="0">
                  <c:v>96 h</c:v>
                </c:pt>
                <c:pt idx="1">
                  <c:v>132 h</c:v>
                </c:pt>
                <c:pt idx="2">
                  <c:v>168 h</c:v>
                </c:pt>
              </c:strCache>
            </c:strRef>
          </c:cat>
          <c:val>
            <c:numRef>
              <c:f>(results!$I$4,results!$I$8,results!$I$12)</c:f>
              <c:numCache>
                <c:formatCode>0.000</c:formatCode>
                <c:ptCount val="3"/>
                <c:pt idx="0">
                  <c:v>0.26724999999999999</c:v>
                </c:pt>
                <c:pt idx="1">
                  <c:v>0.63312500000000105</c:v>
                </c:pt>
                <c:pt idx="2">
                  <c:v>1.3656250000000008</c:v>
                </c:pt>
              </c:numCache>
            </c:numRef>
          </c:val>
          <c:smooth val="0"/>
        </c:ser>
        <c:ser>
          <c:idx val="2"/>
          <c:order val="2"/>
          <c:tx>
            <c:v>HD + 2x EAA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results!$B$5,results!$B$10,results!$B$13)</c:f>
              <c:strCache>
                <c:ptCount val="3"/>
                <c:pt idx="0">
                  <c:v>96 h</c:v>
                </c:pt>
                <c:pt idx="1">
                  <c:v>132 h</c:v>
                </c:pt>
                <c:pt idx="2">
                  <c:v>168 h</c:v>
                </c:pt>
              </c:strCache>
            </c:strRef>
          </c:cat>
          <c:val>
            <c:numRef>
              <c:f>(results!$M$4,results!$M$8,results!$M$12)</c:f>
              <c:numCache>
                <c:formatCode>0.000</c:formatCode>
                <c:ptCount val="3"/>
                <c:pt idx="0">
                  <c:v>0.28400000000000036</c:v>
                </c:pt>
                <c:pt idx="1">
                  <c:v>0.91562500000000036</c:v>
                </c:pt>
                <c:pt idx="2">
                  <c:v>1.657500000000000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5043576"/>
        <c:axId val="145043968"/>
      </c:lineChart>
      <c:catAx>
        <c:axId val="145043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5043968"/>
        <c:crosses val="autoZero"/>
        <c:auto val="1"/>
        <c:lblAlgn val="ctr"/>
        <c:lblOffset val="100"/>
        <c:noMultiLvlLbl val="0"/>
      </c:catAx>
      <c:valAx>
        <c:axId val="145043968"/>
        <c:scaling>
          <c:orientation val="minMax"/>
          <c:max val="2"/>
          <c:min val="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g wet weigh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5043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041543209876544"/>
          <c:y val="0.11553444444444444"/>
          <c:w val="0.37935744671987881"/>
          <c:h val="0.174282509609587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HD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results!$B$19,results!$B$23,results!$B$27)</c:f>
              <c:strCache>
                <c:ptCount val="3"/>
                <c:pt idx="0">
                  <c:v>96 h</c:v>
                </c:pt>
                <c:pt idx="1">
                  <c:v>132 h</c:v>
                </c:pt>
                <c:pt idx="2">
                  <c:v>168 h</c:v>
                </c:pt>
              </c:strCache>
            </c:strRef>
          </c:cat>
          <c:val>
            <c:numRef>
              <c:f>(results!$E$19,results!$E$23,results!$E$27)</c:f>
              <c:numCache>
                <c:formatCode>0.000</c:formatCode>
                <c:ptCount val="3"/>
                <c:pt idx="0">
                  <c:v>3.5750000000000504E-2</c:v>
                </c:pt>
                <c:pt idx="1">
                  <c:v>8.6250000000001603E-2</c:v>
                </c:pt>
                <c:pt idx="2">
                  <c:v>0.26125000000000176</c:v>
                </c:pt>
              </c:numCache>
            </c:numRef>
          </c:val>
          <c:smooth val="0"/>
        </c:ser>
        <c:ser>
          <c:idx val="1"/>
          <c:order val="1"/>
          <c:tx>
            <c:v>HD + 2x sucrose</c:v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results!$B$19,results!$B$23,results!$B$27)</c:f>
              <c:strCache>
                <c:ptCount val="3"/>
                <c:pt idx="0">
                  <c:v>96 h</c:v>
                </c:pt>
                <c:pt idx="1">
                  <c:v>132 h</c:v>
                </c:pt>
                <c:pt idx="2">
                  <c:v>168 h</c:v>
                </c:pt>
              </c:strCache>
            </c:strRef>
          </c:cat>
          <c:val>
            <c:numRef>
              <c:f>(results!$L$19,results!$L$23,results!$L$27)</c:f>
              <c:numCache>
                <c:formatCode>0.000</c:formatCode>
                <c:ptCount val="3"/>
                <c:pt idx="0">
                  <c:v>4.149999999999987E-2</c:v>
                </c:pt>
                <c:pt idx="1">
                  <c:v>8.7500000000001465E-2</c:v>
                </c:pt>
                <c:pt idx="2">
                  <c:v>0.22125000000000061</c:v>
                </c:pt>
              </c:numCache>
            </c:numRef>
          </c:val>
          <c:smooth val="0"/>
        </c:ser>
        <c:ser>
          <c:idx val="2"/>
          <c:order val="2"/>
          <c:tx>
            <c:v>HD + 2x EAA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results!$B$19,results!$B$23,results!$B$27)</c:f>
              <c:strCache>
                <c:ptCount val="3"/>
                <c:pt idx="0">
                  <c:v>96 h</c:v>
                </c:pt>
                <c:pt idx="1">
                  <c:v>132 h</c:v>
                </c:pt>
                <c:pt idx="2">
                  <c:v>168 h</c:v>
                </c:pt>
              </c:strCache>
            </c:strRef>
          </c:cat>
          <c:val>
            <c:numRef>
              <c:f>(results!$S$19,results!$S$23,results!$S$27)</c:f>
              <c:numCache>
                <c:formatCode>0.000</c:formatCode>
                <c:ptCount val="3"/>
                <c:pt idx="0">
                  <c:v>3.9500000000000091E-2</c:v>
                </c:pt>
                <c:pt idx="1">
                  <c:v>0.1187500000000008</c:v>
                </c:pt>
                <c:pt idx="2">
                  <c:v>0.2562500000000009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5044752"/>
        <c:axId val="145045144"/>
      </c:lineChart>
      <c:catAx>
        <c:axId val="1450447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arval 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5045144"/>
        <c:crossesAt val="0"/>
        <c:auto val="1"/>
        <c:lblAlgn val="ctr"/>
        <c:lblOffset val="100"/>
        <c:noMultiLvlLbl val="0"/>
      </c:catAx>
      <c:valAx>
        <c:axId val="145045144"/>
        <c:scaling>
          <c:orientation val="minMax"/>
          <c:max val="0.30000000000000004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g dry weigh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50447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992559523809528"/>
          <c:y val="9.5659820585457953E-2"/>
          <c:w val="0.3731999062076895"/>
          <c:h val="0.1482128267827734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uswertung!$Q$66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P$90,Auswertung!$P$94,Auswertung!$P$98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N$66,Auswertung!$N$70,Auswertung!$N$74)</c:f>
              <c:numCache>
                <c:formatCode>0.000</c:formatCode>
                <c:ptCount val="3"/>
                <c:pt idx="0">
                  <c:v>10.234316000000002</c:v>
                </c:pt>
                <c:pt idx="1">
                  <c:v>24.422299999999996</c:v>
                </c:pt>
                <c:pt idx="2">
                  <c:v>70.02806250000000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Q$78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P$90,Auswertung!$P$94,Auswertung!$P$98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N$78,Auswertung!$N$82,Auswertung!$N$86)</c:f>
              <c:numCache>
                <c:formatCode>0.000</c:formatCode>
                <c:ptCount val="3"/>
                <c:pt idx="0">
                  <c:v>11.168232</c:v>
                </c:pt>
                <c:pt idx="1">
                  <c:v>36.5182</c:v>
                </c:pt>
                <c:pt idx="2">
                  <c:v>71.92683750000000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Q$90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P$90,Auswertung!$P$94,Auswertung!$P$98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N$90,Auswertung!$N$94,Auswertung!$N$98)</c:f>
              <c:numCache>
                <c:formatCode>0.000</c:formatCode>
                <c:ptCount val="3"/>
                <c:pt idx="0">
                  <c:v>13.148584</c:v>
                </c:pt>
                <c:pt idx="1">
                  <c:v>58.565087500000004</c:v>
                </c:pt>
                <c:pt idx="2">
                  <c:v>73.08719999999999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812960"/>
        <c:axId val="193813352"/>
      </c:lineChart>
      <c:catAx>
        <c:axId val="1938129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813352"/>
        <c:crosses val="autoZero"/>
        <c:auto val="1"/>
        <c:lblAlgn val="ctr"/>
        <c:lblOffset val="100"/>
        <c:noMultiLvlLbl val="0"/>
      </c:catAx>
      <c:valAx>
        <c:axId val="193813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µg TAG / animal</a:t>
                </a:r>
              </a:p>
            </c:rich>
          </c:tx>
          <c:layout>
            <c:manualLayout>
              <c:xMode val="edge"/>
              <c:yMode val="edge"/>
              <c:x val="3.7645448323066391E-2"/>
              <c:y val="0.231405895691609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8129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3702469135802464"/>
          <c:y val="0.59437833333333334"/>
          <c:w val="0.35871574074074075"/>
          <c:h val="0.23629888888888889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uswertung!$L$12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K$36,Auswertung!$K$40,Auswertung!$K$44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I$12,Auswertung!$I$16,Auswertung!$I$20)</c:f>
              <c:numCache>
                <c:formatCode>General</c:formatCode>
                <c:ptCount val="3"/>
                <c:pt idx="0">
                  <c:v>16.631844600000001</c:v>
                </c:pt>
                <c:pt idx="1">
                  <c:v>31.330940625000004</c:v>
                </c:pt>
                <c:pt idx="2">
                  <c:v>65.07920812500000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L$24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K$36,Auswertung!$K$40,Auswertung!$K$44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I$24,Auswertung!$I$28,Auswertung!$I$32)</c:f>
              <c:numCache>
                <c:formatCode>General</c:formatCode>
                <c:ptCount val="3"/>
                <c:pt idx="0">
                  <c:v>16.4433726</c:v>
                </c:pt>
                <c:pt idx="1">
                  <c:v>33.510148125000001</c:v>
                </c:pt>
                <c:pt idx="2">
                  <c:v>63.10614187500000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L$36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K$36,Auswertung!$K$40,Auswertung!$K$44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I$36,Auswertung!$I$40,Auswertung!$I$44)</c:f>
              <c:numCache>
                <c:formatCode>General</c:formatCode>
                <c:ptCount val="3"/>
                <c:pt idx="0">
                  <c:v>22.474476600000006</c:v>
                </c:pt>
                <c:pt idx="1">
                  <c:v>67.700146875000002</c:v>
                </c:pt>
                <c:pt idx="2">
                  <c:v>73.36903125000000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814136"/>
        <c:axId val="193814528"/>
      </c:lineChart>
      <c:catAx>
        <c:axId val="1938141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814528"/>
        <c:crosses val="autoZero"/>
        <c:auto val="1"/>
        <c:lblAlgn val="ctr"/>
        <c:lblOffset val="100"/>
        <c:noMultiLvlLbl val="0"/>
      </c:catAx>
      <c:valAx>
        <c:axId val="1938145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µg protein / anima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8141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115401234567901"/>
          <c:y val="0.58312555555555567"/>
          <c:w val="0.3825648148148148"/>
          <c:h val="0.236989282589676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uswertung!$Q$60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P$84,Auswertung!$P$88,Auswertung!$P$92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N$60,Auswertung!$N$64,Auswertung!$N$68)</c:f>
              <c:numCache>
                <c:formatCode>General</c:formatCode>
                <c:ptCount val="3"/>
                <c:pt idx="0">
                  <c:v>1.6181500000000002</c:v>
                </c:pt>
                <c:pt idx="1">
                  <c:v>5.5846875000000011</c:v>
                </c:pt>
                <c:pt idx="2">
                  <c:v>5.656718750000001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Q$72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P$84,Auswertung!$P$88,Auswertung!$P$92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N$72,Auswertung!$N$76,Auswertung!$N$80)</c:f>
              <c:numCache>
                <c:formatCode>General</c:formatCode>
                <c:ptCount val="3"/>
                <c:pt idx="0">
                  <c:v>1.4141000000000001</c:v>
                </c:pt>
                <c:pt idx="1">
                  <c:v>4.9767187500000007</c:v>
                </c:pt>
                <c:pt idx="2">
                  <c:v>4.987343750000000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Q$84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P$84,Auswertung!$P$88,Auswertung!$P$92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N$84,Auswertung!$N$88,Auswertung!$N$92)</c:f>
              <c:numCache>
                <c:formatCode>General</c:formatCode>
                <c:ptCount val="3"/>
                <c:pt idx="0">
                  <c:v>2.3708999999999998</c:v>
                </c:pt>
                <c:pt idx="1">
                  <c:v>6.0339062500000011</c:v>
                </c:pt>
                <c:pt idx="2">
                  <c:v>5.79468750000000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562296"/>
        <c:axId val="193815312"/>
      </c:lineChart>
      <c:catAx>
        <c:axId val="193562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815312"/>
        <c:crosses val="autoZero"/>
        <c:auto val="1"/>
        <c:lblAlgn val="ctr"/>
        <c:lblOffset val="100"/>
        <c:noMultiLvlLbl val="0"/>
      </c:catAx>
      <c:valAx>
        <c:axId val="193815312"/>
        <c:scaling>
          <c:orientation val="minMax"/>
          <c:max val="14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mol glycerol / anima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5622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1743518518518526"/>
          <c:y val="0.10497277777777775"/>
          <c:w val="0.34728703703703706"/>
          <c:h val="0.236989282589676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HD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2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K$39,Auswertung!$K$43,Auswertung!$K$47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I$15,Auswertung!$I$19,Auswertung!$I$23)</c:f>
              <c:numCache>
                <c:formatCode>General</c:formatCode>
                <c:ptCount val="3"/>
                <c:pt idx="0">
                  <c:v>14.075683</c:v>
                </c:pt>
                <c:pt idx="1">
                  <c:v>36.245990625000005</c:v>
                </c:pt>
                <c:pt idx="2">
                  <c:v>71.99694687500000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L$27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K$39,Auswertung!$K$43,Auswertung!$K$47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I$27,Auswertung!$I$31,Auswertung!$I$35)</c:f>
              <c:numCache>
                <c:formatCode>General</c:formatCode>
                <c:ptCount val="3"/>
                <c:pt idx="0">
                  <c:v>15.531021000000003</c:v>
                </c:pt>
                <c:pt idx="1">
                  <c:v>29.303618749999998</c:v>
                </c:pt>
                <c:pt idx="2">
                  <c:v>66.60569062499999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L$39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K$39,Auswertung!$K$43,Auswertung!$K$47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I$39,Auswertung!$I$43,Auswertung!$I$47)</c:f>
              <c:numCache>
                <c:formatCode>General</c:formatCode>
                <c:ptCount val="3"/>
                <c:pt idx="0">
                  <c:v>16.793599</c:v>
                </c:pt>
                <c:pt idx="1">
                  <c:v>43.143184374999997</c:v>
                </c:pt>
                <c:pt idx="2">
                  <c:v>70.68678124999999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816096"/>
        <c:axId val="193816488"/>
      </c:lineChart>
      <c:catAx>
        <c:axId val="193816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816488"/>
        <c:crosses val="autoZero"/>
        <c:auto val="1"/>
        <c:lblAlgn val="ctr"/>
        <c:lblOffset val="100"/>
        <c:noMultiLvlLbl val="0"/>
      </c:catAx>
      <c:valAx>
        <c:axId val="193816488"/>
        <c:scaling>
          <c:orientation val="minMax"/>
          <c:max val="8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µg</a:t>
                </a:r>
                <a:r>
                  <a:rPr lang="en-US" sz="1050" b="1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protein / animal</a:t>
                </a:r>
                <a:endParaRPr lang="en-US" sz="1050" b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816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161697530864197"/>
          <c:y val="6.5259444444444439E-2"/>
          <c:w val="0.38118425925925925"/>
          <c:h val="0.2144905555555555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uswertung!$P$66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O$90,Auswertung!$O$94,Auswertung!$O$98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M$66,Auswertung!$M$70,Auswertung!$M$74)</c:f>
              <c:numCache>
                <c:formatCode>0.000</c:formatCode>
                <c:ptCount val="3"/>
                <c:pt idx="0">
                  <c:v>8.7697778</c:v>
                </c:pt>
                <c:pt idx="1">
                  <c:v>29.597023125</c:v>
                </c:pt>
                <c:pt idx="2">
                  <c:v>76.71357437500000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P$78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O$90,Auswertung!$O$94,Auswertung!$O$98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M$78,Auswertung!$M$82,Auswertung!$M$86)</c:f>
              <c:numCache>
                <c:formatCode>0.000</c:formatCode>
                <c:ptCount val="3"/>
                <c:pt idx="0">
                  <c:v>9.8160267999999995</c:v>
                </c:pt>
                <c:pt idx="1">
                  <c:v>28.200846249999998</c:v>
                </c:pt>
                <c:pt idx="2">
                  <c:v>78.16277062499999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P$90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O$90,Auswertung!$O$94,Auswertung!$O$98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M$90,Auswertung!$M$94,Auswertung!$M$98)</c:f>
              <c:numCache>
                <c:formatCode>0.000</c:formatCode>
                <c:ptCount val="3"/>
                <c:pt idx="0">
                  <c:v>10.274114200000001</c:v>
                </c:pt>
                <c:pt idx="1">
                  <c:v>33.555803124999997</c:v>
                </c:pt>
                <c:pt idx="2">
                  <c:v>68.40720562500001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3817272"/>
        <c:axId val="193817664"/>
      </c:lineChart>
      <c:catAx>
        <c:axId val="193817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817664"/>
        <c:crosses val="autoZero"/>
        <c:auto val="1"/>
        <c:lblAlgn val="ctr"/>
        <c:lblOffset val="100"/>
        <c:noMultiLvlLbl val="0"/>
      </c:catAx>
      <c:valAx>
        <c:axId val="193817664"/>
        <c:scaling>
          <c:orientation val="minMax"/>
          <c:max val="8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µg TAG / anima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817272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584351851851856"/>
          <c:y val="0.10048944444444446"/>
          <c:w val="0.38048364197530865"/>
          <c:h val="0.2292433333333333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Auswertung!$P$60</c:f>
              <c:strCache>
                <c:ptCount val="1"/>
                <c:pt idx="0">
                  <c:v>HD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(Auswertung!$O$84,Auswertung!$O$88,Auswertung!$O$92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M$60,Auswertung!$M$64,Auswertung!$M$68)</c:f>
              <c:numCache>
                <c:formatCode>General</c:formatCode>
                <c:ptCount val="3"/>
                <c:pt idx="0" formatCode="0.0000">
                  <c:v>1.2404500000000001</c:v>
                </c:pt>
                <c:pt idx="1">
                  <c:v>4.3959375000000005</c:v>
                </c:pt>
                <c:pt idx="2">
                  <c:v>7.4882812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uswertung!$P$72</c:f>
              <c:strCache>
                <c:ptCount val="1"/>
                <c:pt idx="0">
                  <c:v>HD + 2x sucro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Auswertung!$O$84,Auswertung!$O$88,Auswertung!$O$92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M$72,Auswertung!$M$76,Auswertung!$M$80)</c:f>
              <c:numCache>
                <c:formatCode>General</c:formatCode>
                <c:ptCount val="3"/>
                <c:pt idx="0">
                  <c:v>1.1240999999999999</c:v>
                </c:pt>
                <c:pt idx="1">
                  <c:v>3.6762499999999996</c:v>
                </c:pt>
                <c:pt idx="2">
                  <c:v>5.425937500000000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uswertung!$P$84</c:f>
              <c:strCache>
                <c:ptCount val="1"/>
                <c:pt idx="0">
                  <c:v>HD + 2x EAA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(Auswertung!$O$84,Auswertung!$O$88,Auswertung!$O$92)</c:f>
              <c:strCache>
                <c:ptCount val="3"/>
                <c:pt idx="0">
                  <c:v>96h</c:v>
                </c:pt>
                <c:pt idx="1">
                  <c:v>132h</c:v>
                </c:pt>
                <c:pt idx="2">
                  <c:v>168h</c:v>
                </c:pt>
              </c:strCache>
            </c:strRef>
          </c:cat>
          <c:val>
            <c:numRef>
              <c:f>(Auswertung!$M$84,Auswertung!$M$88,Auswertung!$M$92)</c:f>
              <c:numCache>
                <c:formatCode>General</c:formatCode>
                <c:ptCount val="3"/>
                <c:pt idx="0">
                  <c:v>1.4117500000000003</c:v>
                </c:pt>
                <c:pt idx="1">
                  <c:v>6.1206250000000004</c:v>
                </c:pt>
                <c:pt idx="2">
                  <c:v>12.8785937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3296576"/>
        <c:axId val="143298536"/>
      </c:lineChart>
      <c:catAx>
        <c:axId val="143296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3298536"/>
        <c:crosses val="autoZero"/>
        <c:auto val="1"/>
        <c:lblAlgn val="ctr"/>
        <c:lblOffset val="100"/>
        <c:noMultiLvlLbl val="0"/>
      </c:catAx>
      <c:valAx>
        <c:axId val="143298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mol glycerol / anima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3296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613888888888886"/>
          <c:y val="9.025055555555557E-2"/>
          <c:w val="0.39432407407407405"/>
          <c:h val="0.2030450000000000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0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318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397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995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279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873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399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921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337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271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256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07625-E8A7-4AF3-A8AE-25B60931DC60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E8CCF9-FFFB-4A20-BE49-10F50E4EFD5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226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7" Type="http://schemas.openxmlformats.org/officeDocument/2006/relationships/chart" Target="../charts/chart9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39140" y="83820"/>
            <a:ext cx="226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 1 (V46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5364480" y="83820"/>
            <a:ext cx="226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 2 (V50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Gerader Verbinder 9"/>
          <p:cNvCxnSpPr/>
          <p:nvPr/>
        </p:nvCxnSpPr>
        <p:spPr>
          <a:xfrm>
            <a:off x="4305300" y="0"/>
            <a:ext cx="0" cy="685800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8" name="Diagramm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0434938"/>
              </p:ext>
            </p:extLst>
          </p:nvPr>
        </p:nvGraphicFramePr>
        <p:xfrm>
          <a:off x="170657" y="913426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Diagramm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1552872"/>
              </p:ext>
            </p:extLst>
          </p:nvPr>
        </p:nvGraphicFramePr>
        <p:xfrm>
          <a:off x="4876255" y="984636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Diagramm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9396593"/>
              </p:ext>
            </p:extLst>
          </p:nvPr>
        </p:nvGraphicFramePr>
        <p:xfrm>
          <a:off x="4615950" y="3517571"/>
          <a:ext cx="3830400" cy="254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1168440" y="4213860"/>
            <a:ext cx="18133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o dry weight </a:t>
            </a: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measurements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05103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11" grpId="0">
        <p:bldAsOne/>
      </p:bldGraphic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39140" y="83820"/>
            <a:ext cx="226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 1 (V46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5364480" y="83820"/>
            <a:ext cx="226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 2 (V50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Diagram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1344713"/>
              </p:ext>
            </p:extLst>
          </p:nvPr>
        </p:nvGraphicFramePr>
        <p:xfrm>
          <a:off x="135919" y="267462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Diagramm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0594743"/>
              </p:ext>
            </p:extLst>
          </p:nvPr>
        </p:nvGraphicFramePr>
        <p:xfrm>
          <a:off x="144780" y="74676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Diagramm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1678192"/>
              </p:ext>
            </p:extLst>
          </p:nvPr>
        </p:nvGraphicFramePr>
        <p:xfrm>
          <a:off x="198120" y="461010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0" name="Gerader Verbinder 9"/>
          <p:cNvCxnSpPr/>
          <p:nvPr/>
        </p:nvCxnSpPr>
        <p:spPr>
          <a:xfrm>
            <a:off x="4305300" y="0"/>
            <a:ext cx="0" cy="685800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1" name="Diagramm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2194885"/>
              </p:ext>
            </p:extLst>
          </p:nvPr>
        </p:nvGraphicFramePr>
        <p:xfrm>
          <a:off x="4826334" y="733561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Diagramm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0575901"/>
              </p:ext>
            </p:extLst>
          </p:nvPr>
        </p:nvGraphicFramePr>
        <p:xfrm>
          <a:off x="4792980" y="265938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" name="Diagramm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4936059"/>
              </p:ext>
            </p:extLst>
          </p:nvPr>
        </p:nvGraphicFramePr>
        <p:xfrm>
          <a:off x="4815840" y="465582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15564752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39140" y="83820"/>
            <a:ext cx="226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 1 (V46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5364480" y="83820"/>
            <a:ext cx="2262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 2 (V50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Gerader Verbinder 9"/>
          <p:cNvCxnSpPr/>
          <p:nvPr/>
        </p:nvCxnSpPr>
        <p:spPr>
          <a:xfrm>
            <a:off x="4305300" y="0"/>
            <a:ext cx="0" cy="685800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4" name="Diagramm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1851987"/>
              </p:ext>
            </p:extLst>
          </p:nvPr>
        </p:nvGraphicFramePr>
        <p:xfrm>
          <a:off x="5012719" y="65532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Diagramm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6784638"/>
              </p:ext>
            </p:extLst>
          </p:nvPr>
        </p:nvGraphicFramePr>
        <p:xfrm>
          <a:off x="4937760" y="262128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Diagramm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9702532"/>
              </p:ext>
            </p:extLst>
          </p:nvPr>
        </p:nvGraphicFramePr>
        <p:xfrm>
          <a:off x="4970416" y="454914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Diagramm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8026231"/>
              </p:ext>
            </p:extLst>
          </p:nvPr>
        </p:nvGraphicFramePr>
        <p:xfrm>
          <a:off x="350520" y="65532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Diagramm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1945710"/>
              </p:ext>
            </p:extLst>
          </p:nvPr>
        </p:nvGraphicFramePr>
        <p:xfrm>
          <a:off x="289560" y="259080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1" name="Diagramm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3906933"/>
              </p:ext>
            </p:extLst>
          </p:nvPr>
        </p:nvGraphicFramePr>
        <p:xfrm>
          <a:off x="271598" y="452628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983408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5</Words>
  <Application>Microsoft Office PowerPoint</Application>
  <PresentationFormat>Bildschirmpräsentation (4:3)</PresentationFormat>
  <Paragraphs>24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isa</dc:creator>
  <cp:lastModifiedBy>Lisa</cp:lastModifiedBy>
  <cp:revision>11</cp:revision>
  <dcterms:created xsi:type="dcterms:W3CDTF">2018-05-03T14:44:46Z</dcterms:created>
  <dcterms:modified xsi:type="dcterms:W3CDTF">2018-05-04T13:58:50Z</dcterms:modified>
</cp:coreProperties>
</file>